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3"/>
  </p:sldMasterIdLst>
  <p:sldIdLst>
    <p:sldId id="256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745"/>
    <p:restoredTop sz="94646"/>
  </p:normalViewPr>
  <p:slideViewPr>
    <p:cSldViewPr snapToGrid="0">
      <p:cViewPr varScale="1">
        <p:scale>
          <a:sx n="104" d="100"/>
          <a:sy n="104" d="100"/>
        </p:scale>
        <p:origin x="11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Master" Target="slideMasters/slideMaster1.xml"/><Relationship Id="rId7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eigh Church" userId="653e9461-fa64-4d4d-bf11-f97acf9d2993" providerId="ADAL" clId="{73A9FF1F-5426-4AC5-B00E-F15C1DD69048}"/>
    <pc:docChg chg="modSld">
      <pc:chgData name="Leigh Church" userId="653e9461-fa64-4d4d-bf11-f97acf9d2993" providerId="ADAL" clId="{73A9FF1F-5426-4AC5-B00E-F15C1DD69048}" dt="2024-05-01T15:56:30.983" v="0" actId="1076"/>
      <pc:docMkLst>
        <pc:docMk/>
      </pc:docMkLst>
      <pc:sldChg chg="modSp mod">
        <pc:chgData name="Leigh Church" userId="653e9461-fa64-4d4d-bf11-f97acf9d2993" providerId="ADAL" clId="{73A9FF1F-5426-4AC5-B00E-F15C1DD69048}" dt="2024-05-01T15:56:30.983" v="0" actId="1076"/>
        <pc:sldMkLst>
          <pc:docMk/>
          <pc:sldMk cId="2227015264" sldId="256"/>
        </pc:sldMkLst>
        <pc:spChg chg="mod">
          <ac:chgData name="Leigh Church" userId="653e9461-fa64-4d4d-bf11-f97acf9d2993" providerId="ADAL" clId="{73A9FF1F-5426-4AC5-B00E-F15C1DD69048}" dt="2024-05-01T15:56:30.983" v="0" actId="1076"/>
          <ac:spMkLst>
            <pc:docMk/>
            <pc:sldMk cId="2227015264" sldId="256"/>
            <ac:spMk id="5" creationId="{E0A57264-C7FF-8313-EC5E-A909D2AC2B82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E-QoL scor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A$2:$A$4</c:f>
              <c:strCache>
                <c:ptCount val="3"/>
                <c:pt idx="0">
                  <c:v>Non-novel LTP</c:v>
                </c:pt>
                <c:pt idx="1">
                  <c:v>Novel LTP &lt;6 months</c:v>
                </c:pt>
                <c:pt idx="2">
                  <c:v>Novel LTP ≥6 months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47.7</c:v>
                </c:pt>
                <c:pt idx="1">
                  <c:v>39.299999999999997</c:v>
                </c:pt>
                <c:pt idx="2">
                  <c:v>32.299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8D7-4F49-878D-7A21A16323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25924400"/>
        <c:axId val="468130048"/>
      </c:barChart>
      <c:catAx>
        <c:axId val="3259244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8130048"/>
        <c:crosses val="autoZero"/>
        <c:auto val="1"/>
        <c:lblAlgn val="ctr"/>
        <c:lblOffset val="100"/>
        <c:noMultiLvlLbl val="0"/>
      </c:catAx>
      <c:valAx>
        <c:axId val="4681300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59244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579E83-A4E5-2A1B-3A8E-DAF8765FF51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5AD54EC-F980-FCDE-5133-04720FB6AD6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1C8EEA-73D7-E04E-D4ED-3237FB5804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3035A-FEF6-B846-8643-D00405E8C4F6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695ACB-A275-CAC1-CEB2-61FACCC9E1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CF0CEA-07E8-CF25-CF2C-222DFF922A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68A41-20E4-1F47-895A-2998D3F57A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21025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C01680-B905-B653-2140-AA02D94F31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F42169E-11DB-9588-AD8C-5F5C4FC7A8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A8F2C4-1EDA-DA95-F3D7-26D23E74A9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3035A-FEF6-B846-8643-D00405E8C4F6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2B9464-1635-458D-194B-F62EFA203D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4365A7-6F88-0D92-11DC-7E1887E043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68A41-20E4-1F47-895A-2998D3F57A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1493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2CFF6DB-5B97-16E3-1237-6F1C88DD8FE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B502C68-706D-B24B-0B38-68CCDB6712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16DF5C-3CDE-2119-BFC3-CB0C3E8CA2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3035A-FEF6-B846-8643-D00405E8C4F6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90E247-2826-B9FF-96BC-BD4AB0B7A3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D842CE-B85B-A0C9-D742-05068C44CA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68A41-20E4-1F47-895A-2998D3F57A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8578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645746-8100-A83F-C9E1-23335755DB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81A936-A0C7-E97B-29E7-D344FEF1AE1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1EB6A0-EF64-E59D-5BAB-E6FF193A2B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3035A-FEF6-B846-8643-D00405E8C4F6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A6F82C-AB0D-011F-C199-F4BFDA152D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0EB6FE-417E-17A0-BCE7-EF99EFAEBE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68A41-20E4-1F47-895A-2998D3F57A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2538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0AC4A9-83C8-4E8A-B617-32120E14A7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FF07A8E-98ED-3C46-2116-46960C0D7A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905A26-8E23-C1C7-FC3F-301F138122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3035A-FEF6-B846-8643-D00405E8C4F6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3E6F4C-74C9-69BE-F14F-463A0B8DB2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6220A0-3662-8C62-250B-EDEF34E6CB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68A41-20E4-1F47-895A-2998D3F57A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87852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0AD6A6-567D-A11C-0DDF-8ECEEDD101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80682F-2711-9CE9-663C-05F8845A043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48967BF-4E9B-7651-BEB1-DFC89BA806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349DF1E-5C59-0BB4-A1B3-C7E6137CBF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3035A-FEF6-B846-8643-D00405E8C4F6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DC3DD03-FC6B-BBC6-5377-1EA945199E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EB96819-ECFD-E818-D503-C4E7EA2FD6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68A41-20E4-1F47-895A-2998D3F57A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66623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0DC402-FEC2-FBEF-952E-9C1CF0B85E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8A52BA-9E5D-B42D-EAB7-65CBACB85B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C51B02-EBB8-0EEA-4323-2FB38D845E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69349FB-47A7-2FA7-1799-B09914BA8A0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F02DB7F-ADF6-6773-1919-CCA7E45DDEF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2A1241C-40D1-01BF-6DD7-DE0AA91EFB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3035A-FEF6-B846-8643-D00405E8C4F6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37F554A-EFE3-E491-36AE-32D3376DD0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023ECAC-9CEE-7CE1-03A7-CEE48BD40F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68A41-20E4-1F47-895A-2998D3F57A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75283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B0322C-8680-B4B9-61DB-DC82BF2813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3500BDC-A75B-F5A3-DE35-6F01015096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3035A-FEF6-B846-8643-D00405E8C4F6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B13F0A0-EFCE-3D06-83BD-2D911ACF4F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B2A0288-1903-E210-F450-1BC95E70F3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68A41-20E4-1F47-895A-2998D3F57A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2346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51C0829-75CC-9799-9285-AFF56F6EFC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3035A-FEF6-B846-8643-D00405E8C4F6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9047563-F775-EF2C-4158-8644A48915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73C92E2-86F8-4152-1139-7D700E5621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68A41-20E4-1F47-895A-2998D3F57A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2921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F8115B-4CE5-4158-1852-CC577B9386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F86916-6CDE-3DE0-80A4-5F08494889E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FA5C80A-2410-9DA7-D608-6795DFCC13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6A404C-8EA4-CC18-F858-3EE01B3D25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3035A-FEF6-B846-8643-D00405E8C4F6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4F68FE-869C-8CBA-1E23-DDA2FD4B8D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B3FAB7-EF81-F8C6-5816-758C8B27E4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68A41-20E4-1F47-895A-2998D3F57A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50807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9F03C1-DE0F-3EF5-FB5B-12F8C2A64B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21D75B0-26A8-9424-5A10-6DA7481BD64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94A6AB6-DB64-60C1-8900-78134E6169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5B987E6-2297-18EC-C7D9-EA5D8F1A20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3035A-FEF6-B846-8643-D00405E8C4F6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E5DEF8E-C961-885D-45D8-44399207C2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F5B56F-6DB0-7CF5-5DE2-90D93745D0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68A41-20E4-1F47-895A-2998D3F57A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61828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8191856-55D4-B1C5-6C7D-5C7F196029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237E89-1273-94D7-62CB-245C8B791D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596D3D-1C7D-32E0-3944-F762848FF2B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1C3035A-FEF6-B846-8643-D00405E8C4F6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E4E7B7-EA08-797A-627B-EBA27B75B5C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F4EF67-05C1-9EFE-D160-F29E3F9178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0768A41-20E4-1F47-895A-2998D3F57A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92977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AADDB4F4-D080-A5B7-BC93-ADC22CBDE891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217460849"/>
              </p:ext>
            </p:extLst>
          </p:nvPr>
        </p:nvGraphicFramePr>
        <p:xfrm>
          <a:off x="2032000" y="603504"/>
          <a:ext cx="7331456" cy="48033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E0A57264-C7FF-8313-EC5E-A909D2AC2B82}"/>
              </a:ext>
            </a:extLst>
          </p:cNvPr>
          <p:cNvSpPr txBox="1"/>
          <p:nvPr/>
        </p:nvSpPr>
        <p:spPr>
          <a:xfrm rot="16200000">
            <a:off x="1132166" y="2533843"/>
            <a:ext cx="1587229" cy="6558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E-QoL score</a:t>
            </a:r>
          </a:p>
          <a:p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96BDEB9-3775-07AF-B4E2-B2434088AC92}"/>
              </a:ext>
            </a:extLst>
          </p:cNvPr>
          <p:cNvSpPr txBox="1"/>
          <p:nvPr/>
        </p:nvSpPr>
        <p:spPr>
          <a:xfrm>
            <a:off x="3200400" y="5376672"/>
            <a:ext cx="681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=47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A26118F-7A11-3826-9EAA-2EA58A67BAE7}"/>
              </a:ext>
            </a:extLst>
          </p:cNvPr>
          <p:cNvSpPr txBox="1"/>
          <p:nvPr/>
        </p:nvSpPr>
        <p:spPr>
          <a:xfrm>
            <a:off x="5474208" y="5376672"/>
            <a:ext cx="681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=1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BF750D8-94A6-C67B-1D4E-D9F1C0CB88BA}"/>
              </a:ext>
            </a:extLst>
          </p:cNvPr>
          <p:cNvSpPr txBox="1"/>
          <p:nvPr/>
        </p:nvSpPr>
        <p:spPr>
          <a:xfrm>
            <a:off x="7802880" y="5376672"/>
            <a:ext cx="7184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n=99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A971419-0BC6-63B7-0537-8396ED0A0F64}"/>
              </a:ext>
            </a:extLst>
          </p:cNvPr>
          <p:cNvSpPr txBox="1"/>
          <p:nvPr/>
        </p:nvSpPr>
        <p:spPr>
          <a:xfrm>
            <a:off x="1331556" y="6254496"/>
            <a:ext cx="9528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/>
              <a:t>Figure S1. Mean </a:t>
            </a:r>
            <a:r>
              <a:rPr lang="en-US" dirty="0"/>
              <a:t>AE-QoL according to type of LTP (excludes 1 patient on novel LTP for &lt;1 month)</a:t>
            </a:r>
          </a:p>
        </p:txBody>
      </p:sp>
    </p:spTree>
    <p:extLst>
      <p:ext uri="{BB962C8B-B14F-4D97-AF65-F5344CB8AC3E}">
        <p14:creationId xmlns:p14="http://schemas.microsoft.com/office/powerpoint/2010/main" val="22270152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171F37250B19E4397B990449A4AFE9E" ma:contentTypeVersion="21" ma:contentTypeDescription="Create a new document." ma:contentTypeScope="" ma:versionID="92f411752f82c79156a17f582cbc8b50">
  <xsd:schema xmlns:xsd="http://www.w3.org/2001/XMLSchema" xmlns:xs="http://www.w3.org/2001/XMLSchema" xmlns:p="http://schemas.microsoft.com/office/2006/metadata/properties" xmlns:ns2="50039647-6e15-4edb-9661-7a8c9ed728b4" xmlns:ns3="608d09b5-34c3-4845-8988-7eef1c8dffe9" targetNamespace="http://schemas.microsoft.com/office/2006/metadata/properties" ma:root="true" ma:fieldsID="692a79174ea892788af0aea3e097904b" ns2:_="" ns3:_="">
    <xsd:import namespace="50039647-6e15-4edb-9661-7a8c9ed728b4"/>
    <xsd:import namespace="608d09b5-34c3-4845-8988-7eef1c8dffe9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DateTaken" minOccurs="0"/>
                <xsd:element ref="ns2:MediaServiceAutoTags" minOccurs="0"/>
                <xsd:element ref="ns2:MediaLengthInSeconds" minOccurs="0"/>
                <xsd:element ref="ns2:VersionDetails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3:SharedWithUsers" minOccurs="0"/>
                <xsd:element ref="ns3:SharedWithDetails" minOccurs="0"/>
                <xsd:element ref="ns2:Comments" minOccurs="0"/>
                <xsd:element ref="ns2:MediaServiceSearchProperties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0039647-6e15-4edb-9661-7a8c9ed728b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LengthInSeconds" ma:index="14" nillable="true" ma:displayName="MediaLengthInSeconds" ma:hidden="true" ma:internalName="MediaLengthInSeconds" ma:readOnly="true">
      <xsd:simpleType>
        <xsd:restriction base="dms:Unknown"/>
      </xsd:simpleType>
    </xsd:element>
    <xsd:element name="VersionDetails" ma:index="15" nillable="true" ma:displayName="Version Details" ma:format="Dropdown" ma:internalName="VersionDetails">
      <xsd:simpleType>
        <xsd:restriction base="dms:Note">
          <xsd:maxLength value="255"/>
        </xsd:restriction>
      </xsd:simpleType>
    </xsd:element>
    <xsd:element name="lcf76f155ced4ddcb4097134ff3c332f" ma:index="17" nillable="true" ma:taxonomy="true" ma:internalName="lcf76f155ced4ddcb4097134ff3c332f" ma:taxonomyFieldName="MediaServiceImageTags" ma:displayName="Image Tags" ma:readOnly="false" ma:fieldId="{5cf76f15-5ced-4ddc-b409-7134ff3c332f}" ma:taxonomyMulti="true" ma:sspId="91526444-8973-4013-83c9-3a3ac6012607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19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OCR" ma:index="20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2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2" nillable="true" ma:displayName="MediaServiceEventHashCode" ma:hidden="true" ma:internalName="MediaServiceEventHashCode" ma:readOnly="true">
      <xsd:simpleType>
        <xsd:restriction base="dms:Text"/>
      </xsd:simpleType>
    </xsd:element>
    <xsd:element name="Comments" ma:index="25" nillable="true" ma:displayName="Comments" ma:format="Dropdown" ma:internalName="Comments">
      <xsd:simpleType>
        <xsd:restriction base="dms:Text">
          <xsd:maxLength value="255"/>
        </xsd:restriction>
      </xsd:simpleType>
    </xsd:element>
    <xsd:element name="MediaServiceSearchProperties" ma:index="26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Location" ma:index="27" nillable="true" ma:displayName="Location" ma:description="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08d09b5-34c3-4845-8988-7eef1c8dffe9" elementFormDefault="qualified">
    <xsd:import namespace="http://schemas.microsoft.com/office/2006/documentManagement/types"/>
    <xsd:import namespace="http://schemas.microsoft.com/office/infopath/2007/PartnerControls"/>
    <xsd:element name="TaxCatchAll" ma:index="18" nillable="true" ma:displayName="Taxonomy Catch All Column" ma:hidden="true" ma:list="{7022b452-8a2b-4853-ab5e-c5144b3146be}" ma:internalName="TaxCatchAll" ma:showField="CatchAllData" ma:web="608d09b5-34c3-4845-8988-7eef1c8dffe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23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4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9FB45063-4E77-4220-957F-F377E5F40B4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50039647-6e15-4edb-9661-7a8c9ed728b4"/>
    <ds:schemaRef ds:uri="608d09b5-34c3-4845-8988-7eef1c8dffe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43EC9725-D3D9-49F2-94AD-6A318E4B1944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17</TotalTime>
  <Words>33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ne Drewienkiewicz</dc:creator>
  <cp:lastModifiedBy>Open Health Medical Communications</cp:lastModifiedBy>
  <cp:revision>4</cp:revision>
  <dcterms:created xsi:type="dcterms:W3CDTF">2024-04-26T12:16:07Z</dcterms:created>
  <dcterms:modified xsi:type="dcterms:W3CDTF">2024-05-01T15:56:41Z</dcterms:modified>
</cp:coreProperties>
</file>